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92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AF39FD-DB92-4033-8681-8D5CFEEF430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C8122-7C20-4B69-BFE9-036AE3F4A74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4125" y="0"/>
            <a:ext cx="22718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smtClean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altLang="zh-CN" sz="1600" b="1" smtClean="0">
                <a:latin typeface="Arial" pitchFamily="34" charset="0"/>
                <a:cs typeface="Arial" pitchFamily="34" charset="0"/>
              </a:rPr>
              <a:t>Fig.4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图片 4" descr="Fig.4B.jpg"/>
          <p:cNvPicPr>
            <a:picLocks noChangeAspect="1"/>
          </p:cNvPicPr>
          <p:nvPr/>
        </p:nvPicPr>
        <p:blipFill>
          <a:blip r:embed="rId2" cstate="print">
            <a:lum contrast="20000"/>
          </a:blip>
          <a:stretch>
            <a:fillRect/>
          </a:stretch>
        </p:blipFill>
        <p:spPr>
          <a:xfrm>
            <a:off x="848107" y="2969566"/>
            <a:ext cx="2066925" cy="121193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86251" y="4128696"/>
            <a:ext cx="18335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Relative expression level</a:t>
            </a:r>
          </a:p>
          <a:p>
            <a:pPr algn="ctr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(hsa-miR-320c/U6)</a:t>
            </a:r>
          </a:p>
        </p:txBody>
      </p:sp>
      <p:sp>
        <p:nvSpPr>
          <p:cNvPr id="7" name="TextBox 6"/>
          <p:cNvSpPr txBox="1"/>
          <p:nvPr/>
        </p:nvSpPr>
        <p:spPr>
          <a:xfrm rot="-5400000">
            <a:off x="-202213" y="3416895"/>
            <a:ext cx="16192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Relative expression level</a:t>
            </a:r>
          </a:p>
          <a:p>
            <a:pPr algn="ctr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sz="800" b="1" i="1" dirty="0" smtClean="0">
                <a:latin typeface="Arial" pitchFamily="34" charset="0"/>
                <a:cs typeface="Arial" pitchFamily="34" charset="0"/>
              </a:rPr>
              <a:t>SLC2A3/18S</a:t>
            </a:r>
            <a:r>
              <a:rPr lang="en-US" sz="800" b="1" dirty="0" smtClean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67301" y="2766636"/>
            <a:ext cx="6477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&lt; 0.05</a:t>
            </a:r>
          </a:p>
          <a:p>
            <a:pPr algn="ctr"/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r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= -0.74 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04800" y="2247925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057957" y="2247925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-5400000">
            <a:off x="2649828" y="3369997"/>
            <a:ext cx="180020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level</a:t>
            </a:r>
          </a:p>
          <a:p>
            <a:pPr algn="ctr">
              <a:lnSpc>
                <a:spcPts val="14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hsa-miR-320c/U6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图片 11" descr="Fig.1C.jpg"/>
          <p:cNvPicPr>
            <a:picLocks noChangeAspect="1"/>
          </p:cNvPicPr>
          <p:nvPr/>
        </p:nvPicPr>
        <p:blipFill>
          <a:blip r:embed="rId3" cstate="print">
            <a:lum contrast="20000"/>
          </a:blip>
          <a:stretch>
            <a:fillRect/>
          </a:stretch>
        </p:blipFill>
        <p:spPr>
          <a:xfrm>
            <a:off x="3913446" y="2978010"/>
            <a:ext cx="2594992" cy="1445781"/>
          </a:xfrm>
          <a:prstGeom prst="rect">
            <a:avLst/>
          </a:prstGeom>
        </p:spPr>
      </p:pic>
      <p:cxnSp>
        <p:nvCxnSpPr>
          <p:cNvPr id="13" name="直接连接符 12"/>
          <p:cNvCxnSpPr/>
          <p:nvPr/>
        </p:nvCxnSpPr>
        <p:spPr>
          <a:xfrm>
            <a:off x="4258256" y="2942059"/>
            <a:ext cx="8686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5238471" y="2941467"/>
            <a:ext cx="116128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239480" y="2701869"/>
            <a:ext cx="20695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Healthy controls                   SCOS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32</Words>
  <Application>Microsoft Office PowerPoint</Application>
  <PresentationFormat>全屏显示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5</cp:revision>
  <dcterms:created xsi:type="dcterms:W3CDTF">2017-11-27T07:36:01Z</dcterms:created>
  <dcterms:modified xsi:type="dcterms:W3CDTF">2018-08-13T12:25:04Z</dcterms:modified>
</cp:coreProperties>
</file>